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329" r:id="rId2"/>
    <p:sldId id="331" r:id="rId3"/>
    <p:sldId id="336" r:id="rId4"/>
    <p:sldId id="338" r:id="rId5"/>
    <p:sldId id="339" r:id="rId6"/>
    <p:sldId id="340" r:id="rId7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77"/>
    <a:srgbClr val="EEBC96"/>
    <a:srgbClr val="F4D4D4"/>
    <a:srgbClr val="F3D7D1"/>
    <a:srgbClr val="6087CE"/>
    <a:srgbClr val="4674C6"/>
    <a:srgbClr val="83ABD7"/>
    <a:srgbClr val="26457C"/>
    <a:srgbClr val="4472C4"/>
    <a:srgbClr val="9FB7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51" autoAdjust="0"/>
    <p:restoredTop sz="94198" autoAdjust="0"/>
  </p:normalViewPr>
  <p:slideViewPr>
    <p:cSldViewPr>
      <p:cViewPr>
        <p:scale>
          <a:sx n="125" d="100"/>
          <a:sy n="125" d="100"/>
        </p:scale>
        <p:origin x="2478" y="-2304"/>
      </p:cViewPr>
      <p:guideLst>
        <p:guide orient="horz" pos="2653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FF59-7695-48F5-AB78-39D11FDC9794}" type="datetimeFigureOut">
              <a:rPr lang="ko-KR" altLang="en-US" smtClean="0"/>
              <a:t>2025-08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6247F1-F2E7-41F9-89F3-984DCCE2D2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8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60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2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59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1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58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40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1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1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1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W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376307"/>
            <a:ext cx="8018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B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884957"/>
            <a:ext cx="915635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C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1</a:t>
            </a:r>
          </a:p>
          <a:p>
            <a:endParaRPr lang="en-US" altLang="ko-K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4297635"/>
            <a:ext cx="915635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D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2</a:t>
            </a:r>
          </a:p>
          <a:p>
            <a:endParaRPr lang="en-US" altLang="ko-K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3B54158F-72A8-4E56-A363-5C3F9B5661AA}"/>
              </a:ext>
            </a:extLst>
          </p:cNvPr>
          <p:cNvSpPr/>
          <p:nvPr/>
        </p:nvSpPr>
        <p:spPr>
          <a:xfrm>
            <a:off x="0" y="6560606"/>
            <a:ext cx="6264275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 genome re-sequencing of CRISPR/Cas9-mediated white strawberries. Two white strawberry lines (5W and 4W) and one red strawberry line (control, a sibling of 4W and 5W) were subjected to whole genome re-sequencing. The sequencing reads were aligned to the ‘Florida Brilliance’ reference genome. Mutations in sequences at both on-target and off-target candidate sites were analyzed using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ious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e. In the 5W mutant line (A), a homozygous 2-bp deletion was identified in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10-1B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 the 4W mutant line (B), a biallelic mutation (a 3-bp deletion and a 4-bp deletion) were identified in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10-1B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ew or no mutations were detected at the off-target sites in the 5W and 4W lines. Similarly, few or no mutations were detected at the on-target and off-target sites in the control (C)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9362F54D-66CB-4FB9-91DE-0018B80998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23164"/>
            <a:ext cx="4483545" cy="2340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82E7F5A9-E2B9-40FD-9EAB-587D1DC46E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2884957"/>
            <a:ext cx="4482000" cy="1299385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6AC5053A-5F6A-45F7-ABD1-6F3146E690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5749" y="4297635"/>
            <a:ext cx="4482000" cy="2262971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81686" y="223902"/>
            <a:ext cx="12186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bp (GA) deletion</a:t>
            </a:r>
          </a:p>
        </p:txBody>
      </p:sp>
    </p:spTree>
    <p:extLst>
      <p:ext uri="{BB962C8B-B14F-4D97-AF65-F5344CB8AC3E}">
        <p14:creationId xmlns:p14="http://schemas.microsoft.com/office/powerpoint/2010/main" val="1717865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W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9409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3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3016669"/>
            <a:ext cx="912429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4</a:t>
            </a:r>
          </a:p>
          <a:p>
            <a:endParaRPr lang="en-US" altLang="ko-K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5666835"/>
            <a:ext cx="912429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5</a:t>
            </a:r>
          </a:p>
          <a:p>
            <a:endParaRPr lang="en-US" altLang="ko-K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7C535789-5918-4CD5-8DE7-EF6A7A10AC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56266"/>
            <a:ext cx="4482000" cy="2458296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636BE89B-E55B-4E39-9155-3E449BB1F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3016669"/>
            <a:ext cx="4482000" cy="2532923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F6AAA7D9-EEFA-48D6-811F-784AEC7343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5749" y="5666835"/>
            <a:ext cx="4482000" cy="2151009"/>
          </a:xfrm>
          <a:prstGeom prst="rect">
            <a:avLst/>
          </a:prstGeom>
        </p:spPr>
      </p:pic>
      <p:sp>
        <p:nvSpPr>
          <p:cNvPr id="26" name="직사각형 25">
            <a:extLst>
              <a:ext uri="{FF2B5EF4-FFF2-40B4-BE49-F238E27FC236}">
                <a16:creationId xmlns:a16="http://schemas.microsoft.com/office/drawing/2014/main" id="{9D428172-D903-4160-AB08-BF8C4C64518A}"/>
              </a:ext>
            </a:extLst>
          </p:cNvPr>
          <p:cNvSpPr/>
          <p:nvPr/>
        </p:nvSpPr>
        <p:spPr>
          <a:xfrm>
            <a:off x="0" y="7817844"/>
            <a:ext cx="62642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</a:rPr>
              <a:t> 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ontinued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60658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8018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B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671716"/>
            <a:ext cx="915635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C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1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4616950"/>
            <a:ext cx="915635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D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2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81686" y="509032"/>
            <a:ext cx="12186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bp (GA) deletion</a:t>
            </a: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E908826B-5670-4DF0-91EC-B1C820B971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50459"/>
            <a:ext cx="4482000" cy="2115890"/>
          </a:xfrm>
          <a:prstGeom prst="rect">
            <a:avLst/>
          </a:prstGeom>
        </p:spPr>
      </p:pic>
      <p:sp>
        <p:nvSpPr>
          <p:cNvPr id="18" name="직사각형 17">
            <a:extLst>
              <a:ext uri="{FF2B5EF4-FFF2-40B4-BE49-F238E27FC236}">
                <a16:creationId xmlns:a16="http://schemas.microsoft.com/office/drawing/2014/main" id="{A0D497B8-A28C-4E02-982B-9A1DB211FA53}"/>
              </a:ext>
            </a:extLst>
          </p:cNvPr>
          <p:cNvSpPr/>
          <p:nvPr/>
        </p:nvSpPr>
        <p:spPr>
          <a:xfrm>
            <a:off x="2594813" y="251197"/>
            <a:ext cx="28055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 bp (CGA) deletion and 4 bp (ACGA) deletion</a:t>
            </a:r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B39B0A9D-823C-4B13-870A-DD0925B77D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2671716"/>
            <a:ext cx="4482000" cy="1827953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F14E4630-2051-4783-8472-1FA5C9AD3F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5749" y="4616950"/>
            <a:ext cx="4482000" cy="2330991"/>
          </a:xfrm>
          <a:prstGeom prst="rect">
            <a:avLst/>
          </a:prstGeom>
        </p:spPr>
      </p:pic>
      <p:sp>
        <p:nvSpPr>
          <p:cNvPr id="25" name="직사각형 24">
            <a:extLst>
              <a:ext uri="{FF2B5EF4-FFF2-40B4-BE49-F238E27FC236}">
                <a16:creationId xmlns:a16="http://schemas.microsoft.com/office/drawing/2014/main" id="{F7A77360-3864-4974-A26A-228C967D1698}"/>
              </a:ext>
            </a:extLst>
          </p:cNvPr>
          <p:cNvSpPr/>
          <p:nvPr/>
        </p:nvSpPr>
        <p:spPr>
          <a:xfrm>
            <a:off x="0" y="6947941"/>
            <a:ext cx="62642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</a:rPr>
              <a:t> 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ontinued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1124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W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3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976400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4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5496909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5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81686" y="509032"/>
            <a:ext cx="12186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bp (GA) deletion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A0D497B8-A28C-4E02-982B-9A1DB211FA53}"/>
              </a:ext>
            </a:extLst>
          </p:cNvPr>
          <p:cNvSpPr/>
          <p:nvPr/>
        </p:nvSpPr>
        <p:spPr>
          <a:xfrm>
            <a:off x="2594813" y="251197"/>
            <a:ext cx="28055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 bp (CGA) deletion and 4 bp (ACGA) deletion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3EFEA2F7-796C-4A23-920D-F2DBB95FF5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50459"/>
            <a:ext cx="4482000" cy="2423369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4B4DBE3D-917F-4EF0-B8A6-95BCA0A9D7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2976400"/>
            <a:ext cx="4482000" cy="2423369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AE52E5B7-ABA3-4111-B14A-6F11D9F5CC3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766"/>
          <a:stretch/>
        </p:blipFill>
        <p:spPr>
          <a:xfrm>
            <a:off x="1435749" y="5496909"/>
            <a:ext cx="4482000" cy="2531152"/>
          </a:xfrm>
          <a:prstGeom prst="rect">
            <a:avLst/>
          </a:prstGeom>
        </p:spPr>
      </p:pic>
      <p:sp>
        <p:nvSpPr>
          <p:cNvPr id="23" name="직사각형 22">
            <a:extLst>
              <a:ext uri="{FF2B5EF4-FFF2-40B4-BE49-F238E27FC236}">
                <a16:creationId xmlns:a16="http://schemas.microsoft.com/office/drawing/2014/main" id="{475E762B-3255-40B8-A263-E6F47E9A33DA}"/>
              </a:ext>
            </a:extLst>
          </p:cNvPr>
          <p:cNvSpPr/>
          <p:nvPr/>
        </p:nvSpPr>
        <p:spPr>
          <a:xfrm>
            <a:off x="0" y="8028061"/>
            <a:ext cx="62642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</a:rPr>
              <a:t> 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ontinued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24634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11512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 (red fruit)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8018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B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974897"/>
            <a:ext cx="915635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C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1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4827696"/>
            <a:ext cx="915635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D,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2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81686" y="509032"/>
            <a:ext cx="12186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bp (GA) deletion</a:t>
            </a: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F8167CB3-FC84-4277-81D9-68539ACC09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50459"/>
            <a:ext cx="4482000" cy="240154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DC198C5B-6580-478F-8008-6EA12A70A7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4827696"/>
            <a:ext cx="4482000" cy="2552293"/>
          </a:xfrm>
          <a:prstGeom prst="rect">
            <a:avLst/>
          </a:prstGeom>
        </p:spPr>
      </p:pic>
      <p:sp>
        <p:nvSpPr>
          <p:cNvPr id="23" name="직사각형 22">
            <a:extLst>
              <a:ext uri="{FF2B5EF4-FFF2-40B4-BE49-F238E27FC236}">
                <a16:creationId xmlns:a16="http://schemas.microsoft.com/office/drawing/2014/main" id="{29225648-679D-40D4-B3BC-6ABFD8CE82E8}"/>
              </a:ext>
            </a:extLst>
          </p:cNvPr>
          <p:cNvSpPr/>
          <p:nvPr/>
        </p:nvSpPr>
        <p:spPr>
          <a:xfrm>
            <a:off x="0" y="7379989"/>
            <a:ext cx="62642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</a:rPr>
              <a:t> 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ontinued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7822869E-2D41-49C8-843D-E326875840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9949" y="2974897"/>
            <a:ext cx="4482000" cy="1722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71404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11512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 (red fruit)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912429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3</a:t>
            </a:r>
          </a:p>
          <a:p>
            <a:endParaRPr lang="en-US" altLang="ko-KR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923032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4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5476926"/>
            <a:ext cx="91242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Off-target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andidate #5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81686" y="509032"/>
            <a:ext cx="12186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 bp (GA) deletion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B1A4BA0B-81D5-43E4-84D7-08080257A3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5749" y="450459"/>
            <a:ext cx="4482000" cy="2379279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C6D2B1CD-47CF-4422-960F-C4BB626116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5749" y="2923032"/>
            <a:ext cx="4482000" cy="2440733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4D0B3BF4-6A40-4BF2-92F9-40842C80AD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5749" y="5476926"/>
            <a:ext cx="4482000" cy="2443123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947E2B38-A6A4-495C-A392-E007663926FD}"/>
              </a:ext>
            </a:extLst>
          </p:cNvPr>
          <p:cNvSpPr/>
          <p:nvPr/>
        </p:nvSpPr>
        <p:spPr>
          <a:xfrm>
            <a:off x="0" y="7920049"/>
            <a:ext cx="626427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</a:rPr>
              <a:t>Supplementary Figure 6.</a:t>
            </a:r>
            <a:r>
              <a:rPr lang="en-US" altLang="ko-KR" sz="1000" dirty="0">
                <a:latin typeface="Times New Roman" panose="02020603050405020304" pitchFamily="18" charset="0"/>
              </a:rPr>
              <a:t> 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ontinued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8242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82</TotalTime>
  <Words>335</Words>
  <Application>Microsoft Office PowerPoint</Application>
  <PresentationFormat>사용자 지정</PresentationFormat>
  <Paragraphs>64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e Yoon Kim</dc:creator>
  <cp:lastModifiedBy>이만보</cp:lastModifiedBy>
  <cp:revision>306</cp:revision>
  <dcterms:created xsi:type="dcterms:W3CDTF">2012-09-21T02:05:55Z</dcterms:created>
  <dcterms:modified xsi:type="dcterms:W3CDTF">2025-08-29T12:56:55Z</dcterms:modified>
</cp:coreProperties>
</file>